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47402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5103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54674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58310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747487" y="573133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747487" y="54061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508101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47558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443069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41055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378036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747487" y="34552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47487" y="313004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747487" y="28048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47487" y="24797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47487" y="21545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47487" y="182940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47487" y="15042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47487" y="11790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99220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402856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506492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610129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5520912" y="4755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931062" y="4755851"/>
              <a:ext cx="2589849" cy="0"/>
            </a:xfrm>
            <a:custGeom>
              <a:avLst/>
              <a:pathLst>
                <a:path w="2589849" h="0">
                  <a:moveTo>
                    <a:pt x="25898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931062" y="4755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889501" y="3130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027285" y="3130048"/>
              <a:ext cx="2862216" cy="0"/>
            </a:xfrm>
            <a:custGeom>
              <a:avLst/>
              <a:pathLst>
                <a:path w="2862216" h="0">
                  <a:moveTo>
                    <a:pt x="28622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027285" y="3130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5736997" y="3780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967045" y="3780369"/>
              <a:ext cx="2769951" cy="0"/>
            </a:xfrm>
            <a:custGeom>
              <a:avLst/>
              <a:pathLst>
                <a:path w="2769951" h="0">
                  <a:moveTo>
                    <a:pt x="27699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967045" y="3780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5523091" y="5081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911991" y="5081011"/>
              <a:ext cx="2611100" cy="0"/>
            </a:xfrm>
            <a:custGeom>
              <a:avLst/>
              <a:pathLst>
                <a:path w="2611100" h="0">
                  <a:moveTo>
                    <a:pt x="26111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911991" y="5081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6029227" y="2154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198244" y="2154567"/>
              <a:ext cx="2830983" cy="0"/>
            </a:xfrm>
            <a:custGeom>
              <a:avLst/>
              <a:pathLst>
                <a:path w="2830983" h="0">
                  <a:moveTo>
                    <a:pt x="28309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198244" y="2154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6058896" y="1179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498102" y="1179085"/>
              <a:ext cx="2560794" cy="0"/>
            </a:xfrm>
            <a:custGeom>
              <a:avLst/>
              <a:pathLst>
                <a:path w="2560794" h="0">
                  <a:moveTo>
                    <a:pt x="25607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498102" y="1179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975154" y="24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3134842" y="2479727"/>
              <a:ext cx="2840312" cy="0"/>
            </a:xfrm>
            <a:custGeom>
              <a:avLst/>
              <a:pathLst>
                <a:path w="2840312" h="0">
                  <a:moveTo>
                    <a:pt x="28403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134842" y="24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932670" y="1829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3389895" y="1829406"/>
              <a:ext cx="2542775" cy="0"/>
            </a:xfrm>
            <a:custGeom>
              <a:avLst/>
              <a:pathLst>
                <a:path w="2542775" h="0">
                  <a:moveTo>
                    <a:pt x="25427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389895" y="1829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5755687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896097" y="4105530"/>
              <a:ext cx="2859589" cy="0"/>
            </a:xfrm>
            <a:custGeom>
              <a:avLst/>
              <a:pathLst>
                <a:path w="2859589" h="0">
                  <a:moveTo>
                    <a:pt x="28595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896097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5810899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3057627" y="3455209"/>
              <a:ext cx="2753271" cy="0"/>
            </a:xfrm>
            <a:custGeom>
              <a:avLst/>
              <a:pathLst>
                <a:path w="2753271" h="0">
                  <a:moveTo>
                    <a:pt x="27532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057627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6053657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970766" y="2804888"/>
              <a:ext cx="3082891" cy="0"/>
            </a:xfrm>
            <a:custGeom>
              <a:avLst/>
              <a:pathLst>
                <a:path w="3082891" h="0">
                  <a:moveTo>
                    <a:pt x="30828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970766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6122859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3376283" y="1504245"/>
              <a:ext cx="2746576" cy="0"/>
            </a:xfrm>
            <a:custGeom>
              <a:avLst/>
              <a:pathLst>
                <a:path w="2746576" h="0">
                  <a:moveTo>
                    <a:pt x="27465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376283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5692426" y="4430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957268" y="4430690"/>
              <a:ext cx="2735157" cy="0"/>
            </a:xfrm>
            <a:custGeom>
              <a:avLst/>
              <a:pathLst>
                <a:path w="2735157" h="0">
                  <a:moveTo>
                    <a:pt x="27351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957268" y="4430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5797601" y="5731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3155109" y="5731333"/>
              <a:ext cx="2642491" cy="0"/>
            </a:xfrm>
            <a:custGeom>
              <a:avLst/>
              <a:pathLst>
                <a:path w="2642491" h="0">
                  <a:moveTo>
                    <a:pt x="2642491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3155109" y="5731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3"/>
            <p:cNvSpPr/>
            <p:nvPr/>
          </p:nvSpPr>
          <p:spPr>
            <a:xfrm>
              <a:off x="4201161" y="47310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4"/>
            <p:cNvSpPr/>
            <p:nvPr/>
          </p:nvSpPr>
          <p:spPr>
            <a:xfrm>
              <a:off x="4433567" y="3105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5"/>
            <p:cNvSpPr/>
            <p:nvPr/>
          </p:nvSpPr>
          <p:spPr>
            <a:xfrm>
              <a:off x="4327195" y="37555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4192715" y="5056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4588910" y="21297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4753673" y="11542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4530172" y="2454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4636457" y="1804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1"/>
            <p:cNvSpPr/>
            <p:nvPr/>
          </p:nvSpPr>
          <p:spPr>
            <a:xfrm>
              <a:off x="4301066" y="40807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2"/>
            <p:cNvSpPr/>
            <p:nvPr/>
          </p:nvSpPr>
          <p:spPr>
            <a:xfrm>
              <a:off x="4409437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3"/>
            <p:cNvSpPr/>
            <p:nvPr/>
          </p:nvSpPr>
          <p:spPr>
            <a:xfrm>
              <a:off x="4487386" y="27800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t84"/>
            <p:cNvSpPr/>
            <p:nvPr/>
          </p:nvSpPr>
          <p:spPr>
            <a:xfrm>
              <a:off x="4724745" y="14794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t85"/>
            <p:cNvSpPr/>
            <p:nvPr/>
          </p:nvSpPr>
          <p:spPr>
            <a:xfrm>
              <a:off x="4300021" y="44058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6"/>
            <p:cNvSpPr/>
            <p:nvPr/>
          </p:nvSpPr>
          <p:spPr>
            <a:xfrm>
              <a:off x="4451529" y="570650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47487" y="54061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tx88"/>
            <p:cNvSpPr/>
            <p:nvPr/>
          </p:nvSpPr>
          <p:spPr>
            <a:xfrm>
              <a:off x="1571946" y="5694969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90" name="tx89"/>
            <p:cNvSpPr/>
            <p:nvPr/>
          </p:nvSpPr>
          <p:spPr>
            <a:xfrm>
              <a:off x="1261193" y="504306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673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1148183" y="471794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65727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1261193" y="439278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8714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1261193" y="406762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1995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1204688" y="37424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17939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1148183" y="341725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8313928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1204688" y="30921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69481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1204688" y="27669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772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1261193" y="244182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2680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1204688" y="21166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85585</a:t>
              </a:r>
            </a:p>
          </p:txBody>
        </p:sp>
        <p:sp>
          <p:nvSpPr>
            <p:cNvPr id="100" name="tx99"/>
            <p:cNvSpPr/>
            <p:nvPr/>
          </p:nvSpPr>
          <p:spPr>
            <a:xfrm>
              <a:off x="1204688" y="179145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86375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1204688" y="14663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820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1317698" y="1141134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111</a:t>
              </a:r>
            </a:p>
          </p:txBody>
        </p:sp>
        <p:sp>
          <p:nvSpPr>
            <p:cNvPr id="103" name="pl102"/>
            <p:cNvSpPr/>
            <p:nvPr/>
          </p:nvSpPr>
          <p:spPr>
            <a:xfrm>
              <a:off x="1712693" y="57313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712693" y="54061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712693" y="50810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12693" y="47558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712693" y="44306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712693" y="41055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712693" y="37803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712693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712693" y="31300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712693" y="28048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712693" y="2479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712693" y="21545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712693" y="1829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712693" y="15042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712693" y="11790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95583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99220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402856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506492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610129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tx122"/>
            <p:cNvSpPr/>
            <p:nvPr/>
          </p:nvSpPr>
          <p:spPr>
            <a:xfrm>
              <a:off x="1878157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24" name="tx123"/>
            <p:cNvSpPr/>
            <p:nvPr/>
          </p:nvSpPr>
          <p:spPr>
            <a:xfrm>
              <a:off x="2914521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25" name="tx124"/>
            <p:cNvSpPr/>
            <p:nvPr/>
          </p:nvSpPr>
          <p:spPr>
            <a:xfrm>
              <a:off x="3950884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26" name="tx125"/>
            <p:cNvSpPr/>
            <p:nvPr/>
          </p:nvSpPr>
          <p:spPr>
            <a:xfrm>
              <a:off x="4987247" y="5987313"/>
              <a:ext cx="155361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27" name="tx126"/>
            <p:cNvSpPr/>
            <p:nvPr/>
          </p:nvSpPr>
          <p:spPr>
            <a:xfrm>
              <a:off x="6023610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28" name="tx127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129" name="tx128"/>
            <p:cNvSpPr/>
            <p:nvPr/>
          </p:nvSpPr>
          <p:spPr>
            <a:xfrm>
              <a:off x="2146181" y="6214430"/>
              <a:ext cx="3786336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|| id:ebi-a-GCST006095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09:49Z</dcterms:modified>
  <cp:category/>
</cp:coreProperties>
</file>